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9" r:id="rId3"/>
    <p:sldId id="260" r:id="rId4"/>
  </p:sldIdLst>
  <p:sldSz cx="12192000" cy="6858000"/>
  <p:notesSz cx="6858000" cy="9144000"/>
  <p:defaultTextStyle>
    <a:defPPr>
      <a:defRPr lang="en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59"/>
  </p:normalViewPr>
  <p:slideViewPr>
    <p:cSldViewPr snapToGrid="0">
      <p:cViewPr varScale="1">
        <p:scale>
          <a:sx n="113" d="100"/>
          <a:sy n="113" d="100"/>
        </p:scale>
        <p:origin x="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5B8658-791F-110C-6D3D-9983FB0DBD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239753-138F-6A51-9BCB-88FBEB9C21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5C4E18-5415-9863-A147-0E5848DBE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FFE6CD-297A-F64A-B0BF-9CF91ECEE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C9743F-EDF8-60A0-A1E6-7FB3C0DFD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568557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02028-8DFA-F913-77C5-B9213CBD3B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4C2C8C-4F09-7164-9333-8B1FE8A82F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AFF174-3C37-D3BE-F352-F01C73045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387053-AC9F-CC0C-BB03-5FEEF92F5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7F2512-7B4F-B476-0A65-7A5F73800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039516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9ED722B-01FD-C4D4-511E-D455C2072D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4EEB4C-C81C-C243-6E18-4C82EC230B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89E5D0-1D09-573E-136A-5DDBC54ED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B9996A-8FFB-F49B-2EA9-FF628B7EE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5DB9F0-1265-59FD-10A9-E1E26F82C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93989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05894-7A60-B4D1-BD92-B264B146F2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515FAA-5D9E-65B9-1BB0-09940318CE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AE295C-1802-4B45-2F2D-BDAC2CC4C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4F7B13-9410-E7A9-0427-CCCA2F5D3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823F9A-4E49-4E5E-AB3F-FA24A01E6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33183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4303D-F0E8-4DAE-0FC1-5BD2D09343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FB6BDC-B614-586B-9197-9B5DE2CE2C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07745F-C876-4BA5-2759-0AB3D127A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76FD9E-1164-109D-1090-96EBA4FDB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E41363-99A3-E221-272B-24B8BBC55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061816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747B01-BF0C-A426-764A-A58DF180B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50B2DC-78FC-C399-701B-0271A76FFC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43A714-F7BF-C7A6-6362-05F98C6B51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B2B036-13DD-FA0C-4C64-CB97F51AB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0543FD-ABC8-B682-E356-B59A1A0B29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3EB513-5537-DFC6-AC3E-91B4E7FE4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948499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34EF2-7571-E6E6-C2FA-41C071852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EA6933-E813-B092-58D9-7F9FF2DDB3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69AE9B-90A0-D2E7-361D-1BBD162EF5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1646718-5779-0BE7-6DC0-0FFBA98AB7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07CAACA-9ABE-6DDF-776F-CAB7EA698F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1AF014-8B9C-CE64-38E2-9B4077B08E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7C17D8-73C6-E007-C88A-B0EC0E145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8F9000-DFB8-8C4B-C868-17C6F6B78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478324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C34163-C126-FCBA-962F-700692EE70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6DCD1AA-BD06-64B7-68C1-80E84182F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0B1FE5-94C4-19D4-2A58-BDB9EF966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BAD7F1-FD07-8922-B741-F7EFA55AA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078680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06CBC55-FA05-CE59-90A2-5B32E9F93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95CDDA-EFB4-09D3-6492-742E7A899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6672DD-DCC1-0DB8-95B8-A3F0E5D27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760413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29D954-B3F1-B8CD-D670-C7F63477F4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CB979C-79D9-9930-3D33-E2B05F4E1F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A80C7C-5D58-4FBA-ED49-F50759755D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AF8CA5-7920-F6DD-0B14-0624BF47E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2DB450-689D-E8BD-08A3-E07C70C19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6F5A55-DEDD-2DC4-E6D6-9EDB62C1D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507975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DE5608-6AB2-EAA0-00CC-F7821815AD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A96CF4-65A6-5FAD-4F95-4B9C90CA03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7E3DDB-BB95-A27F-5209-3C0DDAB865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A51DF3-837D-71FF-8D88-B4B92DD5D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DDF7B6-3906-31CC-30B9-B0B23FFAA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70B665-AA03-F7A5-51E9-D0345106A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700627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A3484D-041B-F25F-A268-41015A802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AFA1E2-631C-8D74-63BA-2F4011EFE5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58CEFF-0037-8AF9-CF83-39E7D0B154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6BAE83-A4E4-1346-8109-161C77A42CB4}" type="datetimeFigureOut">
              <a:rPr lang="en-CN" smtClean="0"/>
              <a:t>2023/5/1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2459E5-0DE0-6478-B46A-ED08E69969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74B090-BCA4-BFB5-399A-64E706214B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207682-2CBD-3A43-8CBE-736FFF304F0E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125814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Group 62">
            <a:extLst>
              <a:ext uri="{FF2B5EF4-FFF2-40B4-BE49-F238E27FC236}">
                <a16:creationId xmlns:a16="http://schemas.microsoft.com/office/drawing/2014/main" id="{8D289BBC-5CDF-F0C4-C15B-1A885CB4554E}"/>
              </a:ext>
            </a:extLst>
          </p:cNvPr>
          <p:cNvGrpSpPr/>
          <p:nvPr/>
        </p:nvGrpSpPr>
        <p:grpSpPr>
          <a:xfrm>
            <a:off x="316050" y="128582"/>
            <a:ext cx="11654820" cy="6769018"/>
            <a:chOff x="316050" y="128582"/>
            <a:chExt cx="11654820" cy="6769018"/>
          </a:xfrm>
        </p:grpSpPr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F4BDB7A2-5467-9EBE-CE69-9C642557AD2C}"/>
                </a:ext>
              </a:extLst>
            </p:cNvPr>
            <p:cNvGrpSpPr/>
            <p:nvPr/>
          </p:nvGrpSpPr>
          <p:grpSpPr>
            <a:xfrm>
              <a:off x="316050" y="128582"/>
              <a:ext cx="11654820" cy="6769018"/>
              <a:chOff x="431800" y="128582"/>
              <a:chExt cx="11654820" cy="6769018"/>
            </a:xfrm>
          </p:grpSpPr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6C55BE6F-C225-40E9-00F9-2D0D8B167F5B}"/>
                  </a:ext>
                </a:extLst>
              </p:cNvPr>
              <p:cNvGrpSpPr/>
              <p:nvPr/>
            </p:nvGrpSpPr>
            <p:grpSpPr>
              <a:xfrm>
                <a:off x="431800" y="128582"/>
                <a:ext cx="11648992" cy="6756020"/>
                <a:chOff x="431800" y="128582"/>
                <a:chExt cx="11648992" cy="675602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4219AA81-45CD-DD08-580D-4E8E3980B86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457200" y="190500"/>
                  <a:ext cx="3240000" cy="3240000"/>
                </a:xfrm>
                <a:prstGeom prst="rect">
                  <a:avLst/>
                </a:prstGeom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DD7E210D-CC01-90AE-4F15-5E97B57315B1}"/>
                    </a:ext>
                  </a:extLst>
                </p:cNvPr>
                <p:cNvSpPr txBox="1"/>
                <p:nvPr/>
              </p:nvSpPr>
              <p:spPr>
                <a:xfrm>
                  <a:off x="1795261" y="463480"/>
                  <a:ext cx="45719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h1</a:t>
                  </a:r>
                </a:p>
              </p:txBody>
            </p:sp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D36F2BFD-01C2-186D-259E-A51DEB3049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148008" y="179382"/>
                  <a:ext cx="3240000" cy="3240000"/>
                </a:xfrm>
                <a:prstGeom prst="rect">
                  <a:avLst/>
                </a:prstGeom>
              </p:spPr>
            </p:pic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42BFFE69-B632-264A-86E3-49E0056D8EE7}"/>
                    </a:ext>
                  </a:extLst>
                </p:cNvPr>
                <p:cNvSpPr txBox="1"/>
                <p:nvPr/>
              </p:nvSpPr>
              <p:spPr>
                <a:xfrm>
                  <a:off x="4498142" y="453321"/>
                  <a:ext cx="45719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h2</a:t>
                  </a:r>
                </a:p>
              </p:txBody>
            </p:sp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47832B3F-8D0E-5FEF-0950-A1650D57B4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5932267" y="145980"/>
                  <a:ext cx="3240000" cy="3240000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B3569B39-6D2F-CCA5-63F3-AF35D8192FA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8840792" y="128582"/>
                  <a:ext cx="3240000" cy="3240000"/>
                </a:xfrm>
                <a:prstGeom prst="rect">
                  <a:avLst/>
                </a:prstGeom>
              </p:spPr>
            </p:pic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22FA95F4-21C0-96C7-8EA3-3364BD6ED49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431800" y="3644602"/>
                  <a:ext cx="3240000" cy="3240000"/>
                </a:xfrm>
                <a:prstGeom prst="rect">
                  <a:avLst/>
                </a:prstGeom>
              </p:spPr>
            </p:pic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id="{DB28844B-3587-BB33-BBC9-9E3621F04C3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160708" y="3644602"/>
                  <a:ext cx="3240000" cy="3240000"/>
                </a:xfrm>
                <a:prstGeom prst="rect">
                  <a:avLst/>
                </a:prstGeom>
              </p:spPr>
            </p:pic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48738CA4-9CAD-E9E3-A9EC-F78D0350C6CA}"/>
                    </a:ext>
                  </a:extLst>
                </p:cNvPr>
                <p:cNvSpPr txBox="1"/>
                <p:nvPr/>
              </p:nvSpPr>
              <p:spPr>
                <a:xfrm>
                  <a:off x="7293825" y="453321"/>
                  <a:ext cx="45719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h3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C7F0F3AD-83FD-E8AC-96C4-135AD42EDED1}"/>
                    </a:ext>
                  </a:extLst>
                </p:cNvPr>
                <p:cNvSpPr txBox="1"/>
                <p:nvPr/>
              </p:nvSpPr>
              <p:spPr>
                <a:xfrm>
                  <a:off x="10202430" y="419392"/>
                  <a:ext cx="45719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h4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72CCE30B-F740-DF48-75CE-84128F887728}"/>
                    </a:ext>
                  </a:extLst>
                </p:cNvPr>
                <p:cNvSpPr txBox="1"/>
                <p:nvPr/>
              </p:nvSpPr>
              <p:spPr>
                <a:xfrm>
                  <a:off x="1795259" y="3955072"/>
                  <a:ext cx="45719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h5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4EE37061-C619-3C6C-6C77-A9914E6B0C31}"/>
                    </a:ext>
                  </a:extLst>
                </p:cNvPr>
                <p:cNvSpPr txBox="1"/>
                <p:nvPr/>
              </p:nvSpPr>
              <p:spPr>
                <a:xfrm>
                  <a:off x="4519409" y="3947453"/>
                  <a:ext cx="45719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h6</a:t>
                  </a:r>
                </a:p>
              </p:txBody>
            </p:sp>
          </p:grpSp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458B9178-0551-C339-0232-1DCC469086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942641" y="3644602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7FD2AA5B-28E1-8D16-E7D7-FB4466A3C4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846620" y="3657600"/>
                <a:ext cx="3240000" cy="3240000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B77FFA96-565B-46DF-765A-72FE69E220A8}"/>
                  </a:ext>
                </a:extLst>
              </p:cNvPr>
              <p:cNvSpPr txBox="1"/>
              <p:nvPr/>
            </p:nvSpPr>
            <p:spPr>
              <a:xfrm>
                <a:off x="7264938" y="3947453"/>
                <a:ext cx="4571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PK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-I1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DAD5C42-C599-502E-CA54-F7B5F949E6D1}"/>
                  </a:ext>
                </a:extLst>
              </p:cNvPr>
              <p:cNvSpPr txBox="1"/>
              <p:nvPr/>
            </p:nvSpPr>
            <p:spPr>
              <a:xfrm>
                <a:off x="10148673" y="3947453"/>
                <a:ext cx="4571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PK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-I2</a:t>
                </a:r>
              </a:p>
            </p:txBody>
          </p:sp>
        </p:grp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E27D4C8-498C-1AF9-C833-E06E18B6EAC3}"/>
                </a:ext>
              </a:extLst>
            </p:cNvPr>
            <p:cNvSpPr txBox="1"/>
            <p:nvPr/>
          </p:nvSpPr>
          <p:spPr>
            <a:xfrm rot="16200000">
              <a:off x="2052735" y="1611273"/>
              <a:ext cx="674346" cy="23083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5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A600B2B-0D62-A421-5892-BFA519E029E4}"/>
                </a:ext>
              </a:extLst>
            </p:cNvPr>
            <p:cNvSpPr txBox="1"/>
            <p:nvPr/>
          </p:nvSpPr>
          <p:spPr>
            <a:xfrm rot="16200000">
              <a:off x="4667196" y="1526115"/>
              <a:ext cx="844662" cy="23083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81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2CB5EE7-3234-4E1F-8ADE-2692E385F7D9}"/>
                </a:ext>
              </a:extLst>
            </p:cNvPr>
            <p:cNvSpPr txBox="1"/>
            <p:nvPr/>
          </p:nvSpPr>
          <p:spPr>
            <a:xfrm rot="16200000">
              <a:off x="7517763" y="1590118"/>
              <a:ext cx="694423" cy="23083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70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5E72353-7701-093D-AD82-58531C2B61DF}"/>
                </a:ext>
              </a:extLst>
            </p:cNvPr>
            <p:cNvSpPr txBox="1"/>
            <p:nvPr/>
          </p:nvSpPr>
          <p:spPr>
            <a:xfrm rot="16200000">
              <a:off x="10359981" y="1517301"/>
              <a:ext cx="827037" cy="23083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4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F08AFBA-79EB-377D-9BB8-A9EFCA985956}"/>
                </a:ext>
              </a:extLst>
            </p:cNvPr>
            <p:cNvSpPr txBox="1"/>
            <p:nvPr/>
          </p:nvSpPr>
          <p:spPr>
            <a:xfrm rot="16200000">
              <a:off x="4765387" y="5060122"/>
              <a:ext cx="648277" cy="23083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4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FA6306D-CDF9-46CA-5C52-334A52334C4A}"/>
                </a:ext>
              </a:extLst>
            </p:cNvPr>
            <p:cNvSpPr txBox="1"/>
            <p:nvPr/>
          </p:nvSpPr>
          <p:spPr>
            <a:xfrm rot="16200000">
              <a:off x="7540836" y="5060122"/>
              <a:ext cx="648277" cy="23083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89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8DAACB4-3E51-61DF-7C9F-6D7039789105}"/>
                </a:ext>
              </a:extLst>
            </p:cNvPr>
            <p:cNvSpPr txBox="1"/>
            <p:nvPr/>
          </p:nvSpPr>
          <p:spPr>
            <a:xfrm rot="16200000">
              <a:off x="10448688" y="5060794"/>
              <a:ext cx="649625" cy="23083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2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DDB794F-A863-5807-8892-692ACEC27749}"/>
                </a:ext>
              </a:extLst>
            </p:cNvPr>
            <p:cNvSpPr txBox="1"/>
            <p:nvPr/>
          </p:nvSpPr>
          <p:spPr>
            <a:xfrm rot="16200000">
              <a:off x="1959297" y="4955625"/>
              <a:ext cx="794885" cy="23083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4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BE2E33FF-078A-6BFE-B8BA-73DED6DE2ED1}"/>
              </a:ext>
            </a:extLst>
          </p:cNvPr>
          <p:cNvSpPr txBox="1"/>
          <p:nvPr/>
        </p:nvSpPr>
        <p:spPr>
          <a:xfrm>
            <a:off x="5109500" y="25042"/>
            <a:ext cx="1973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-1</a:t>
            </a:r>
            <a:endParaRPr lang="en-PK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4188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57">
            <a:extLst>
              <a:ext uri="{FF2B5EF4-FFF2-40B4-BE49-F238E27FC236}">
                <a16:creationId xmlns:a16="http://schemas.microsoft.com/office/drawing/2014/main" id="{F76CDD8A-EA2F-6191-5638-01248C61C749}"/>
              </a:ext>
            </a:extLst>
          </p:cNvPr>
          <p:cNvGrpSpPr/>
          <p:nvPr/>
        </p:nvGrpSpPr>
        <p:grpSpPr>
          <a:xfrm>
            <a:off x="259266" y="187034"/>
            <a:ext cx="11895685" cy="6701951"/>
            <a:chOff x="259266" y="187034"/>
            <a:chExt cx="11895685" cy="6701951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AABDA712-8AB7-68EC-D6D3-6ECE944990E3}"/>
                </a:ext>
              </a:extLst>
            </p:cNvPr>
            <p:cNvGrpSpPr/>
            <p:nvPr/>
          </p:nvGrpSpPr>
          <p:grpSpPr>
            <a:xfrm>
              <a:off x="259266" y="187034"/>
              <a:ext cx="11895685" cy="6701951"/>
              <a:chOff x="259266" y="187034"/>
              <a:chExt cx="11895685" cy="6701951"/>
            </a:xfrm>
          </p:grpSpPr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6C55BE6F-C225-40E9-00F9-2D0D8B167F5B}"/>
                  </a:ext>
                </a:extLst>
              </p:cNvPr>
              <p:cNvGrpSpPr/>
              <p:nvPr/>
            </p:nvGrpSpPr>
            <p:grpSpPr>
              <a:xfrm>
                <a:off x="1795259" y="419392"/>
                <a:ext cx="8864370" cy="3766512"/>
                <a:chOff x="1795259" y="419392"/>
                <a:chExt cx="8864370" cy="3766512"/>
              </a:xfrm>
            </p:grpSpPr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DD7E210D-CC01-90AE-4F15-5E97B57315B1}"/>
                    </a:ext>
                  </a:extLst>
                </p:cNvPr>
                <p:cNvSpPr txBox="1"/>
                <p:nvPr/>
              </p:nvSpPr>
              <p:spPr>
                <a:xfrm>
                  <a:off x="1795260" y="463480"/>
                  <a:ext cx="4571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I3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42BFFE69-B632-264A-86E3-49E0056D8EE7}"/>
                    </a:ext>
                  </a:extLst>
                </p:cNvPr>
                <p:cNvSpPr txBox="1"/>
                <p:nvPr/>
              </p:nvSpPr>
              <p:spPr>
                <a:xfrm>
                  <a:off x="4498142" y="453320"/>
                  <a:ext cx="4571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I4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48738CA4-9CAD-E9E3-A9EC-F78D0350C6CA}"/>
                    </a:ext>
                  </a:extLst>
                </p:cNvPr>
                <p:cNvSpPr txBox="1"/>
                <p:nvPr/>
              </p:nvSpPr>
              <p:spPr>
                <a:xfrm>
                  <a:off x="7293825" y="453320"/>
                  <a:ext cx="4571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I5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C7F0F3AD-83FD-E8AC-96C4-135AD42EDED1}"/>
                    </a:ext>
                  </a:extLst>
                </p:cNvPr>
                <p:cNvSpPr txBox="1"/>
                <p:nvPr/>
              </p:nvSpPr>
              <p:spPr>
                <a:xfrm>
                  <a:off x="10202430" y="419392"/>
                  <a:ext cx="4571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I6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72CCE30B-F740-DF48-75CE-84128F887728}"/>
                    </a:ext>
                  </a:extLst>
                </p:cNvPr>
                <p:cNvSpPr txBox="1"/>
                <p:nvPr/>
              </p:nvSpPr>
              <p:spPr>
                <a:xfrm>
                  <a:off x="1795259" y="3955072"/>
                  <a:ext cx="4571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m1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4EE37061-C619-3C6C-6C77-A9914E6B0C31}"/>
                    </a:ext>
                  </a:extLst>
                </p:cNvPr>
                <p:cNvSpPr txBox="1"/>
                <p:nvPr/>
              </p:nvSpPr>
              <p:spPr>
                <a:xfrm>
                  <a:off x="4519409" y="3947452"/>
                  <a:ext cx="4571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PK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-m2</a:t>
                  </a:r>
                </a:p>
              </p:txBody>
            </p:sp>
          </p:grp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B77FFA96-565B-46DF-765A-72FE69E220A8}"/>
                  </a:ext>
                </a:extLst>
              </p:cNvPr>
              <p:cNvSpPr txBox="1"/>
              <p:nvPr/>
            </p:nvSpPr>
            <p:spPr>
              <a:xfrm>
                <a:off x="7264938" y="3947452"/>
                <a:ext cx="4571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PK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-m3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DAD5C42-C599-502E-CA54-F7B5F949E6D1}"/>
                  </a:ext>
                </a:extLst>
              </p:cNvPr>
              <p:cNvSpPr txBox="1"/>
              <p:nvPr/>
            </p:nvSpPr>
            <p:spPr>
              <a:xfrm>
                <a:off x="10148674" y="3947452"/>
                <a:ext cx="4571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PK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-m4</a:t>
                </a:r>
              </a:p>
            </p:txBody>
          </p:sp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0F179FF7-7712-02BF-8803-3F05AA228E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103812" y="187960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9E0B80CC-A6AA-0853-5A0E-FFEC6D5203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970242" y="192024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6AD0CD08-3245-1EB7-6F2F-40294A6F62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59266" y="187034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2D96A8C1-D603-5F14-02B5-67432B620E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914951" y="192972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C7D53F05-9C47-7AF8-BC02-B02064A1C0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59266" y="3648985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AF7D3CE1-F5FC-F8AF-CE92-9B412E4FC5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101846" y="3646332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A22878C3-793E-0C5B-0AEC-7D956D504D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974212" y="3648617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82567CF1-BE44-D999-CFE3-4C3DF9E382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913978" y="3647306"/>
                <a:ext cx="3240000" cy="3240000"/>
              </a:xfrm>
              <a:prstGeom prst="rect">
                <a:avLst/>
              </a:prstGeom>
            </p:spPr>
          </p:pic>
        </p:grp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132F7C7-D54D-9DC4-3AB7-CFBE3F5D718B}"/>
                </a:ext>
              </a:extLst>
            </p:cNvPr>
            <p:cNvSpPr txBox="1"/>
            <p:nvPr/>
          </p:nvSpPr>
          <p:spPr>
            <a:xfrm rot="16200000">
              <a:off x="1940737" y="1629356"/>
              <a:ext cx="74634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6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0DF9E98-9C6A-293B-CAB2-5C8082B7D9D8}"/>
                </a:ext>
              </a:extLst>
            </p:cNvPr>
            <p:cNvSpPr txBox="1"/>
            <p:nvPr/>
          </p:nvSpPr>
          <p:spPr>
            <a:xfrm rot="16200000">
              <a:off x="4808424" y="1629355"/>
              <a:ext cx="74634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5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388F915-400E-F6A6-69FF-31708CE72DF3}"/>
                </a:ext>
              </a:extLst>
            </p:cNvPr>
            <p:cNvSpPr txBox="1"/>
            <p:nvPr/>
          </p:nvSpPr>
          <p:spPr>
            <a:xfrm rot="16200000">
              <a:off x="7617363" y="1571864"/>
              <a:ext cx="861326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3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7952A64E-0514-199D-CCD5-EFD75BBC6750}"/>
                </a:ext>
              </a:extLst>
            </p:cNvPr>
            <p:cNvSpPr txBox="1"/>
            <p:nvPr/>
          </p:nvSpPr>
          <p:spPr>
            <a:xfrm rot="16200000">
              <a:off x="10645918" y="1629354"/>
              <a:ext cx="74634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1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7868015-3E89-0320-0514-335EDA1DF3D8}"/>
                </a:ext>
              </a:extLst>
            </p:cNvPr>
            <p:cNvSpPr txBox="1"/>
            <p:nvPr/>
          </p:nvSpPr>
          <p:spPr>
            <a:xfrm rot="16200000">
              <a:off x="7702143" y="5174475"/>
              <a:ext cx="62298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4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BFEEDAB-76FD-07FD-BE42-B153F23FF0D3}"/>
                </a:ext>
              </a:extLst>
            </p:cNvPr>
            <p:cNvSpPr txBox="1"/>
            <p:nvPr/>
          </p:nvSpPr>
          <p:spPr>
            <a:xfrm rot="16200000">
              <a:off x="10625047" y="5091925"/>
              <a:ext cx="78808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0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3A98021-44E5-D002-C0FB-AA65E2CAFD9D}"/>
                </a:ext>
              </a:extLst>
            </p:cNvPr>
            <p:cNvSpPr txBox="1"/>
            <p:nvPr/>
          </p:nvSpPr>
          <p:spPr>
            <a:xfrm rot="16200000">
              <a:off x="4847016" y="5174475"/>
              <a:ext cx="622982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4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48F5928-BCD3-8C1A-0D4D-BAF00BEC7F23}"/>
                </a:ext>
              </a:extLst>
            </p:cNvPr>
            <p:cNvSpPr txBox="1"/>
            <p:nvPr/>
          </p:nvSpPr>
          <p:spPr>
            <a:xfrm rot="16200000">
              <a:off x="1924443" y="5092807"/>
              <a:ext cx="789847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2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D90CF92-EA9A-DB52-D6E0-A5774D81FD74}"/>
              </a:ext>
            </a:extLst>
          </p:cNvPr>
          <p:cNvSpPr txBox="1"/>
          <p:nvPr/>
        </p:nvSpPr>
        <p:spPr>
          <a:xfrm>
            <a:off x="5418199" y="36736"/>
            <a:ext cx="1973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-1</a:t>
            </a:r>
            <a:endParaRPr lang="en-PK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18073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959E909C-7456-2675-8D0F-4E3C4C6538F2}"/>
              </a:ext>
            </a:extLst>
          </p:cNvPr>
          <p:cNvGrpSpPr/>
          <p:nvPr/>
        </p:nvGrpSpPr>
        <p:grpSpPr>
          <a:xfrm>
            <a:off x="278782" y="187375"/>
            <a:ext cx="9187634" cy="6690194"/>
            <a:chOff x="278782" y="187375"/>
            <a:chExt cx="9187634" cy="6690194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64874610-4D6D-27E4-1610-71B88431CC3E}"/>
                </a:ext>
              </a:extLst>
            </p:cNvPr>
            <p:cNvGrpSpPr/>
            <p:nvPr/>
          </p:nvGrpSpPr>
          <p:grpSpPr>
            <a:xfrm>
              <a:off x="278782" y="187375"/>
              <a:ext cx="6803718" cy="6690194"/>
              <a:chOff x="278782" y="187375"/>
              <a:chExt cx="6803718" cy="6690194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DAD5C42-C599-502E-CA54-F7B5F949E6D1}"/>
                  </a:ext>
                </a:extLst>
              </p:cNvPr>
              <p:cNvSpPr txBox="1"/>
              <p:nvPr/>
            </p:nvSpPr>
            <p:spPr>
              <a:xfrm>
                <a:off x="1619499" y="3940378"/>
                <a:ext cx="4571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PK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-m6</a:t>
                </a:r>
              </a:p>
            </p:txBody>
          </p:sp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39621727-4A86-4FCE-6BE1-655119271D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78782" y="187375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2B50E7CB-65E6-AED1-F848-9C11F65CA8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78782" y="3637569"/>
                <a:ext cx="3240000" cy="3240000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9153540-FDDA-C055-3601-DA3F02C32011}"/>
                  </a:ext>
                </a:extLst>
              </p:cNvPr>
              <p:cNvSpPr txBox="1"/>
              <p:nvPr/>
            </p:nvSpPr>
            <p:spPr>
              <a:xfrm>
                <a:off x="1619499" y="473278"/>
                <a:ext cx="4571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PK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-m5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CFA54E9-7E0C-7E5B-2672-D7D829B2AAAA}"/>
                  </a:ext>
                </a:extLst>
              </p:cNvPr>
              <p:cNvSpPr txBox="1"/>
              <p:nvPr/>
            </p:nvSpPr>
            <p:spPr>
              <a:xfrm>
                <a:off x="5109500" y="357862"/>
                <a:ext cx="1973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-1</a:t>
                </a:r>
                <a:endParaRPr lang="en-PK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F2BAA5B-3B24-D934-C784-EE12DA368A4C}"/>
                </a:ext>
              </a:extLst>
            </p:cNvPr>
            <p:cNvSpPr txBox="1"/>
            <p:nvPr/>
          </p:nvSpPr>
          <p:spPr>
            <a:xfrm rot="16200000">
              <a:off x="1998524" y="5196774"/>
              <a:ext cx="64218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1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2E7A0B3-0B15-4719-0E1E-70E6EC7C513B}"/>
                </a:ext>
              </a:extLst>
            </p:cNvPr>
            <p:cNvSpPr txBox="1"/>
            <p:nvPr/>
          </p:nvSpPr>
          <p:spPr>
            <a:xfrm rot="16200000">
              <a:off x="1943126" y="1568834"/>
              <a:ext cx="752975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2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2753621-999C-6C14-B1BE-EB874908F960}"/>
                </a:ext>
              </a:extLst>
            </p:cNvPr>
            <p:cNvSpPr txBox="1"/>
            <p:nvPr/>
          </p:nvSpPr>
          <p:spPr>
            <a:xfrm rot="16200000">
              <a:off x="8696168" y="3536616"/>
              <a:ext cx="130966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b"/>
              <a:r>
                <a:rPr lang="en-PK" sz="900" b="1" u="none" strike="noStrike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.9103827934964%</a:t>
              </a:r>
              <a:endParaRPr lang="en-PK" sz="900" b="1" i="0" u="none" strike="noStrike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22233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2</Words>
  <Application>Microsoft Macintosh PowerPoint</Application>
  <PresentationFormat>Widescreen</PresentationFormat>
  <Paragraphs>4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 Sikandar</dc:creator>
  <cp:lastModifiedBy>Ali Sikandar</cp:lastModifiedBy>
  <cp:revision>1</cp:revision>
  <dcterms:created xsi:type="dcterms:W3CDTF">2023-05-14T10:44:09Z</dcterms:created>
  <dcterms:modified xsi:type="dcterms:W3CDTF">2023-05-14T10:45:19Z</dcterms:modified>
</cp:coreProperties>
</file>